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029" autoAdjust="0"/>
    <p:restoredTop sz="94660"/>
  </p:normalViewPr>
  <p:slideViewPr>
    <p:cSldViewPr snapToGrid="0" snapToObjects="1" showGuides="1">
      <p:cViewPr varScale="1">
        <p:scale>
          <a:sx n="53" d="100"/>
          <a:sy n="53" d="100"/>
        </p:scale>
        <p:origin x="2172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5948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7138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8724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664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54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9349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303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76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095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365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475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652CC6-C793-4277-BA95-4777031771CC}" type="datetimeFigureOut">
              <a:rPr lang="en-US" smtClean="0"/>
              <a:t>5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CD599-CFFC-4582-8513-6CEA86F3B06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50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Groupe 34"/>
          <p:cNvGrpSpPr/>
          <p:nvPr/>
        </p:nvGrpSpPr>
        <p:grpSpPr>
          <a:xfrm>
            <a:off x="583797" y="1036565"/>
            <a:ext cx="5733052" cy="2745597"/>
            <a:chOff x="809625" y="-209028"/>
            <a:chExt cx="9922354" cy="7216769"/>
          </a:xfrm>
        </p:grpSpPr>
        <p:grpSp>
          <p:nvGrpSpPr>
            <p:cNvPr id="34" name="Groupe 33"/>
            <p:cNvGrpSpPr/>
            <p:nvPr/>
          </p:nvGrpSpPr>
          <p:grpSpPr>
            <a:xfrm>
              <a:off x="809625" y="-209028"/>
              <a:ext cx="9915525" cy="2409303"/>
              <a:chOff x="809625" y="-209028"/>
              <a:chExt cx="9915525" cy="2409303"/>
            </a:xfrm>
          </p:grpSpPr>
          <p:grpSp>
            <p:nvGrpSpPr>
              <p:cNvPr id="23" name="Groupe 22"/>
              <p:cNvGrpSpPr/>
              <p:nvPr/>
            </p:nvGrpSpPr>
            <p:grpSpPr>
              <a:xfrm>
                <a:off x="809625" y="-180975"/>
                <a:ext cx="9915525" cy="2381250"/>
                <a:chOff x="809625" y="-180975"/>
                <a:chExt cx="9915525" cy="2381250"/>
              </a:xfrm>
            </p:grpSpPr>
            <p:pic>
              <p:nvPicPr>
                <p:cNvPr id="3" name="Image 2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2500" t="40926" r="11875" b="35926"/>
                <a:stretch/>
              </p:blipFill>
              <p:spPr>
                <a:xfrm>
                  <a:off x="809625" y="-180975"/>
                  <a:ext cx="9915525" cy="2381250"/>
                </a:xfrm>
                <a:prstGeom prst="rect">
                  <a:avLst/>
                </a:prstGeom>
              </p:spPr>
            </p:pic>
            <p:sp>
              <p:nvSpPr>
                <p:cNvPr id="17" name="ZoneTexte 16"/>
                <p:cNvSpPr txBox="1"/>
                <p:nvPr/>
              </p:nvSpPr>
              <p:spPr>
                <a:xfrm flipH="1">
                  <a:off x="3597274" y="9525"/>
                  <a:ext cx="1755616" cy="7280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/>
                    <a:t>M+Glc+FA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18" name="Connecteur droit avec flèche 17"/>
                <p:cNvCxnSpPr/>
                <p:nvPr/>
              </p:nvCxnSpPr>
              <p:spPr>
                <a:xfrm flipV="1">
                  <a:off x="5011440" y="193675"/>
                  <a:ext cx="554335" cy="51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ZoneTexte 18"/>
                <p:cNvSpPr txBox="1"/>
                <p:nvPr/>
              </p:nvSpPr>
              <p:spPr>
                <a:xfrm>
                  <a:off x="5551374" y="1044577"/>
                  <a:ext cx="1359994" cy="7280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 err="1"/>
                    <a:t>M+Glc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20" name="Connecteur droit avec flèche 19"/>
                <p:cNvCxnSpPr>
                  <a:stCxn id="19" idx="1"/>
                </p:cNvCxnSpPr>
                <p:nvPr/>
              </p:nvCxnSpPr>
              <p:spPr>
                <a:xfrm flipH="1">
                  <a:off x="5051430" y="1408622"/>
                  <a:ext cx="499943" cy="74105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ZoneTexte 20"/>
                <p:cNvSpPr txBox="1"/>
                <p:nvPr/>
              </p:nvSpPr>
              <p:spPr>
                <a:xfrm>
                  <a:off x="3459050" y="1254128"/>
                  <a:ext cx="882803" cy="7280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/>
                    <a:t>M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22" name="Connecteur droit avec flèche 21"/>
                <p:cNvCxnSpPr/>
                <p:nvPr/>
              </p:nvCxnSpPr>
              <p:spPr>
                <a:xfrm flipH="1">
                  <a:off x="2987675" y="1438791"/>
                  <a:ext cx="499950" cy="25348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" name="ZoneTexte 28"/>
              <p:cNvSpPr txBox="1"/>
              <p:nvPr/>
            </p:nvSpPr>
            <p:spPr>
              <a:xfrm>
                <a:off x="1137550" y="-209028"/>
                <a:ext cx="608140" cy="7280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dirty="0"/>
                  <a:t>(a)</a:t>
                </a:r>
                <a:endParaRPr lang="en-GB" sz="1200" dirty="0"/>
              </a:p>
            </p:txBody>
          </p:sp>
        </p:grpSp>
        <p:grpSp>
          <p:nvGrpSpPr>
            <p:cNvPr id="33" name="Groupe 32"/>
            <p:cNvGrpSpPr/>
            <p:nvPr/>
          </p:nvGrpSpPr>
          <p:grpSpPr>
            <a:xfrm>
              <a:off x="809625" y="2200275"/>
              <a:ext cx="9888210" cy="2414588"/>
              <a:chOff x="809625" y="2200275"/>
              <a:chExt cx="9888210" cy="2414588"/>
            </a:xfrm>
          </p:grpSpPr>
          <p:grpSp>
            <p:nvGrpSpPr>
              <p:cNvPr id="24" name="Groupe 23"/>
              <p:cNvGrpSpPr/>
              <p:nvPr/>
            </p:nvGrpSpPr>
            <p:grpSpPr>
              <a:xfrm>
                <a:off x="809625" y="2200275"/>
                <a:ext cx="9888210" cy="2414588"/>
                <a:chOff x="809625" y="2200275"/>
                <a:chExt cx="9888210" cy="2414588"/>
              </a:xfrm>
            </p:grpSpPr>
            <p:pic>
              <p:nvPicPr>
                <p:cNvPr id="2" name="Image 1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2709" t="40648" r="11874" b="35880"/>
                <a:stretch/>
              </p:blipFill>
              <p:spPr>
                <a:xfrm>
                  <a:off x="809625" y="2200275"/>
                  <a:ext cx="9888210" cy="2414588"/>
                </a:xfrm>
                <a:prstGeom prst="rect">
                  <a:avLst/>
                </a:prstGeom>
              </p:spPr>
            </p:pic>
            <p:sp>
              <p:nvSpPr>
                <p:cNvPr id="11" name="ZoneTexte 10"/>
                <p:cNvSpPr txBox="1"/>
                <p:nvPr/>
              </p:nvSpPr>
              <p:spPr>
                <a:xfrm flipH="1">
                  <a:off x="6623050" y="2338386"/>
                  <a:ext cx="1755616" cy="7280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/>
                    <a:t>M+Glc+FA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12" name="Connecteur droit avec flèche 11"/>
                <p:cNvCxnSpPr/>
                <p:nvPr/>
              </p:nvCxnSpPr>
              <p:spPr>
                <a:xfrm flipH="1" flipV="1">
                  <a:off x="6068715" y="2516703"/>
                  <a:ext cx="554335" cy="51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ZoneTexte 12"/>
                <p:cNvSpPr txBox="1"/>
                <p:nvPr/>
              </p:nvSpPr>
              <p:spPr>
                <a:xfrm>
                  <a:off x="5941902" y="3625851"/>
                  <a:ext cx="1359994" cy="7280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 err="1"/>
                    <a:t>M+Glc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14" name="Connecteur droit avec flèche 13"/>
                <p:cNvCxnSpPr>
                  <a:stCxn id="13" idx="1"/>
                </p:cNvCxnSpPr>
                <p:nvPr/>
              </p:nvCxnSpPr>
              <p:spPr>
                <a:xfrm flipH="1">
                  <a:off x="5441951" y="3989896"/>
                  <a:ext cx="499950" cy="7411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ZoneTexte 14"/>
                <p:cNvSpPr txBox="1"/>
                <p:nvPr/>
              </p:nvSpPr>
              <p:spPr>
                <a:xfrm>
                  <a:off x="3878149" y="3768725"/>
                  <a:ext cx="882803" cy="7280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/>
                    <a:t>M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16" name="Connecteur droit avec flèche 15"/>
                <p:cNvCxnSpPr>
                  <a:stCxn id="15" idx="1"/>
                </p:cNvCxnSpPr>
                <p:nvPr/>
              </p:nvCxnSpPr>
              <p:spPr>
                <a:xfrm flipH="1">
                  <a:off x="3378204" y="4132772"/>
                  <a:ext cx="499945" cy="74108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" name="ZoneTexte 29"/>
              <p:cNvSpPr txBox="1"/>
              <p:nvPr/>
            </p:nvSpPr>
            <p:spPr>
              <a:xfrm>
                <a:off x="1108973" y="2228329"/>
                <a:ext cx="619237" cy="7280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dirty="0"/>
                  <a:t>(b)</a:t>
                </a:r>
                <a:endParaRPr lang="en-GB" sz="1200" dirty="0"/>
              </a:p>
            </p:txBody>
          </p:sp>
        </p:grpSp>
        <p:grpSp>
          <p:nvGrpSpPr>
            <p:cNvPr id="32" name="Groupe 31"/>
            <p:cNvGrpSpPr/>
            <p:nvPr/>
          </p:nvGrpSpPr>
          <p:grpSpPr>
            <a:xfrm>
              <a:off x="809625" y="4626491"/>
              <a:ext cx="9922354" cy="2381250"/>
              <a:chOff x="809625" y="4626491"/>
              <a:chExt cx="9922354" cy="2381250"/>
            </a:xfrm>
          </p:grpSpPr>
          <p:grpSp>
            <p:nvGrpSpPr>
              <p:cNvPr id="28" name="Groupe 27"/>
              <p:cNvGrpSpPr/>
              <p:nvPr/>
            </p:nvGrpSpPr>
            <p:grpSpPr>
              <a:xfrm>
                <a:off x="809625" y="4626491"/>
                <a:ext cx="9922354" cy="2381250"/>
                <a:chOff x="804863" y="4638675"/>
                <a:chExt cx="9922354" cy="2381250"/>
              </a:xfrm>
            </p:grpSpPr>
            <p:pic>
              <p:nvPicPr>
                <p:cNvPr id="4" name="Image 3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2708" t="40741" r="11614" b="36110"/>
                <a:stretch/>
              </p:blipFill>
              <p:spPr>
                <a:xfrm>
                  <a:off x="804863" y="4638675"/>
                  <a:ext cx="9922354" cy="2381250"/>
                </a:xfrm>
                <a:prstGeom prst="rect">
                  <a:avLst/>
                </a:prstGeom>
              </p:spPr>
            </p:pic>
            <p:sp>
              <p:nvSpPr>
                <p:cNvPr id="5" name="ZoneTexte 4"/>
                <p:cNvSpPr txBox="1"/>
                <p:nvPr/>
              </p:nvSpPr>
              <p:spPr>
                <a:xfrm flipH="1">
                  <a:off x="3387725" y="4895846"/>
                  <a:ext cx="1755616" cy="7280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/>
                    <a:t>M+Glc+FA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6" name="Connecteur droit avec flèche 5"/>
                <p:cNvCxnSpPr/>
                <p:nvPr/>
              </p:nvCxnSpPr>
              <p:spPr>
                <a:xfrm flipV="1">
                  <a:off x="4801890" y="5080000"/>
                  <a:ext cx="554335" cy="516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" name="ZoneTexte 6"/>
                <p:cNvSpPr txBox="1"/>
                <p:nvPr/>
              </p:nvSpPr>
              <p:spPr>
                <a:xfrm>
                  <a:off x="5379923" y="6178553"/>
                  <a:ext cx="1359994" cy="72808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 err="1"/>
                    <a:t>M+Glc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8" name="Connecteur droit avec flèche 7"/>
                <p:cNvCxnSpPr>
                  <a:stCxn id="7" idx="1"/>
                </p:cNvCxnSpPr>
                <p:nvPr/>
              </p:nvCxnSpPr>
              <p:spPr>
                <a:xfrm flipH="1">
                  <a:off x="4879978" y="6542599"/>
                  <a:ext cx="499945" cy="74105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" name="ZoneTexte 8"/>
                <p:cNvSpPr txBox="1"/>
                <p:nvPr/>
              </p:nvSpPr>
              <p:spPr>
                <a:xfrm>
                  <a:off x="3325700" y="5892798"/>
                  <a:ext cx="882803" cy="72808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BE" sz="1200" dirty="0"/>
                    <a:t>M-H</a:t>
                  </a:r>
                  <a:r>
                    <a:rPr lang="fr-BE" sz="1200" baseline="40000" dirty="0"/>
                    <a:t>+</a:t>
                  </a:r>
                  <a:endParaRPr lang="en-GB" sz="1200" dirty="0"/>
                </a:p>
              </p:txBody>
            </p:sp>
            <p:cxnSp>
              <p:nvCxnSpPr>
                <p:cNvPr id="10" name="Connecteur droit avec flèche 9"/>
                <p:cNvCxnSpPr>
                  <a:stCxn id="9" idx="1"/>
                </p:cNvCxnSpPr>
                <p:nvPr/>
              </p:nvCxnSpPr>
              <p:spPr>
                <a:xfrm flipH="1">
                  <a:off x="2825751" y="6256843"/>
                  <a:ext cx="499948" cy="7411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" name="ZoneTexte 30"/>
              <p:cNvSpPr txBox="1"/>
              <p:nvPr/>
            </p:nvSpPr>
            <p:spPr>
              <a:xfrm>
                <a:off x="1108973" y="4636532"/>
                <a:ext cx="594270" cy="7280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sz="1200" dirty="0"/>
                  <a:t>(c)</a:t>
                </a:r>
                <a:endParaRPr lang="en-GB" sz="1200" dirty="0"/>
              </a:p>
            </p:txBody>
          </p:sp>
        </p:grpSp>
      </p:grpSp>
      <p:sp>
        <p:nvSpPr>
          <p:cNvPr id="36" name="ZoneTexte 35"/>
          <p:cNvSpPr txBox="1"/>
          <p:nvPr/>
        </p:nvSpPr>
        <p:spPr>
          <a:xfrm>
            <a:off x="583797" y="4240284"/>
            <a:ext cx="526498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UGT72AZ2 and UGT72B39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ion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ducts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ulic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apic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iferyl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cohol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strates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MS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2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ferulic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ucoside (UGT72AZ2).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MS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2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apic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id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ucoside (UGT72AZ2).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MS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2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tra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oniferin (UGT72B39). 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5813183" y="1100381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ZoneTexte 36"/>
          <p:cNvSpPr txBox="1"/>
          <p:nvPr/>
        </p:nvSpPr>
        <p:spPr>
          <a:xfrm>
            <a:off x="5813183" y="2009767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5813183" y="292361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5763492" y="1547047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latin typeface="Arial" panose="020B0604020202020204" pitchFamily="34" charset="0"/>
                <a:cs typeface="Arial" panose="020B0604020202020204" pitchFamily="34" charset="0"/>
              </a:rPr>
              <a:t>MS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ZoneTexte 39"/>
          <p:cNvSpPr txBox="1"/>
          <p:nvPr/>
        </p:nvSpPr>
        <p:spPr>
          <a:xfrm>
            <a:off x="5763492" y="2456434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latin typeface="Arial" panose="020B0604020202020204" pitchFamily="34" charset="0"/>
                <a:cs typeface="Arial" panose="020B0604020202020204" pitchFamily="34" charset="0"/>
              </a:rPr>
              <a:t>MS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5763492" y="3373755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BE" sz="1400" dirty="0">
                <a:latin typeface="Arial" panose="020B0604020202020204" pitchFamily="34" charset="0"/>
                <a:cs typeface="Arial" panose="020B0604020202020204" pitchFamily="34" charset="0"/>
              </a:rPr>
              <a:t>MS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86382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6</Words>
  <Application>Microsoft Office PowerPoint</Application>
  <PresentationFormat>Format A4 (210 x 297 mm)</PresentationFormat>
  <Paragraphs>1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 baucher</dc:creator>
  <cp:lastModifiedBy>marie baucher</cp:lastModifiedBy>
  <cp:revision>1</cp:revision>
  <dcterms:created xsi:type="dcterms:W3CDTF">2020-05-29T16:12:09Z</dcterms:created>
  <dcterms:modified xsi:type="dcterms:W3CDTF">2020-05-29T16:12:47Z</dcterms:modified>
</cp:coreProperties>
</file>